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359" r:id="rId2"/>
  </p:sldIdLst>
  <p:sldSz cx="6119813" cy="8099425"/>
  <p:notesSz cx="9866313" cy="67357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51">
          <p15:clr>
            <a:srgbClr val="A4A3A4"/>
          </p15:clr>
        </p15:guide>
        <p15:guide id="2" pos="192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00000"/>
    <a:srgbClr val="0000FF"/>
    <a:srgbClr val="F7F7F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1EE8BF7-8C71-4A41-9FED-22AD30456000}" v="1" dt="2025-12-23T18:17:34.56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15" autoAdjust="0"/>
    <p:restoredTop sz="91182" autoAdjust="0"/>
  </p:normalViewPr>
  <p:slideViewPr>
    <p:cSldViewPr snapToGrid="0">
      <p:cViewPr varScale="1">
        <p:scale>
          <a:sx n="54" d="100"/>
          <a:sy n="54" d="100"/>
        </p:scale>
        <p:origin x="2856" y="274"/>
      </p:cViewPr>
      <p:guideLst>
        <p:guide orient="horz" pos="2551"/>
        <p:guide pos="192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5/10/relationships/revisionInfo" Target="revisionInfo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4276255" cy="33705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587733" y="1"/>
            <a:ext cx="4276254" cy="33705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8F7887-721D-43D3-9B80-934D52076739}" type="datetimeFigureOut">
              <a:rPr kumimoji="1" lang="ja-JP" altLang="en-US" smtClean="0"/>
              <a:t>2025/12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1" y="6397620"/>
            <a:ext cx="4276255" cy="33705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587733" y="6397620"/>
            <a:ext cx="4276254" cy="33705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2A0700-AF77-43FB-9268-FE61CA17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25405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275403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588627" y="0"/>
            <a:ext cx="4275403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4FF5EE-FE4B-472B-A9C8-232ED5865A06}" type="datetimeFigureOut">
              <a:rPr kumimoji="1" lang="ja-JP" altLang="en-US" smtClean="0"/>
              <a:t>2025/12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75113" y="841375"/>
            <a:ext cx="1716087" cy="22733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86632" y="3241586"/>
            <a:ext cx="7893050" cy="265220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6397807"/>
            <a:ext cx="4275403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588627" y="6397807"/>
            <a:ext cx="4275403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A36F8E-1B9E-40DF-82A7-D0F76A94A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93462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A36F8E-1B9E-40DF-82A7-D0F76A94A9FC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79146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25531"/>
            <a:ext cx="5201841" cy="2819800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254073"/>
            <a:ext cx="4589860" cy="1955486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12/24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1453679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12/24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833362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31220"/>
            <a:ext cx="1319585" cy="686388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31220"/>
            <a:ext cx="3882256" cy="686388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12/24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062995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12/24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9018172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19234"/>
            <a:ext cx="5278339" cy="336913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420242"/>
            <a:ext cx="5278339" cy="1771749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12/24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1695764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56097"/>
            <a:ext cx="2600921" cy="51390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56097"/>
            <a:ext cx="2600921" cy="51390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12/24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892269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31221"/>
            <a:ext cx="5278339" cy="156551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85485"/>
            <a:ext cx="2588967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958540"/>
            <a:ext cx="2588967" cy="435156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85485"/>
            <a:ext cx="2601718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958540"/>
            <a:ext cx="2601718" cy="435156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12/24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718133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12/24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103082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12/24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9931969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66169"/>
            <a:ext cx="3098155" cy="575584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12/24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9529052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66169"/>
            <a:ext cx="3098155" cy="575584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ja-JP" altLang="en-US" dirty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989E6-9A7C-4E99-861C-E41D60177B8D}" type="datetimeFigureOut">
              <a:rPr kumimoji="1" lang="ja-JP" altLang="en-US" smtClean="0"/>
              <a:t>2025/12/24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134162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31221"/>
            <a:ext cx="5278339" cy="15655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56097"/>
            <a:ext cx="5278339" cy="51390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A989E6-9A7C-4E99-861C-E41D60177B8D}" type="datetimeFigureOut">
              <a:rPr kumimoji="1" lang="ja-JP" altLang="en-US" smtClean="0"/>
              <a:t>2025/12/24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506969"/>
            <a:ext cx="2065437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A5632C-4312-4B42-8168-B8CB5562F0C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77636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kumimoji="1"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kumimoji="1"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19E34E6-89FA-6640-945A-C8005081D1A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53638B7-0ED1-A88D-AE23-51F01C070FB3}"/>
              </a:ext>
            </a:extLst>
          </p:cNvPr>
          <p:cNvSpPr txBox="1"/>
          <p:nvPr/>
        </p:nvSpPr>
        <p:spPr>
          <a:xfrm>
            <a:off x="4135848" y="4938"/>
            <a:ext cx="19736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1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5A539006-F255-67CA-D65F-8B57C2E0A72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22250339"/>
              </p:ext>
            </p:extLst>
          </p:nvPr>
        </p:nvGraphicFramePr>
        <p:xfrm>
          <a:off x="31902" y="1993059"/>
          <a:ext cx="2330251" cy="17406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3855613" imgH="2698634" progId="Prism8.Document">
                  <p:embed/>
                </p:oleObj>
              </mc:Choice>
              <mc:Fallback>
                <p:oleObj name="Prism 8" r:id="rId3" imgW="3855613" imgH="2698634" progId="Prism8.Document">
                  <p:embed/>
                  <p:pic>
                    <p:nvPicPr>
                      <p:cNvPr id="3" name="オブジェクト 2">
                        <a:extLst>
                          <a:ext uri="{FF2B5EF4-FFF2-40B4-BE49-F238E27FC236}">
                            <a16:creationId xmlns:a16="http://schemas.microsoft.com/office/drawing/2014/main" id="{08B18A85-2842-65FE-CDEC-38781FA9CCB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1902" y="1993059"/>
                        <a:ext cx="2330251" cy="17406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C44F9D3-4107-E12B-F56C-2DE4BFBDDC3F}"/>
              </a:ext>
            </a:extLst>
          </p:cNvPr>
          <p:cNvSpPr txBox="1"/>
          <p:nvPr/>
        </p:nvSpPr>
        <p:spPr>
          <a:xfrm>
            <a:off x="4795" y="1722485"/>
            <a:ext cx="44541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000" b="1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D7DCC678-527D-3EE5-5D6C-22F1872D4A65}"/>
              </a:ext>
            </a:extLst>
          </p:cNvPr>
          <p:cNvSpPr/>
          <p:nvPr/>
        </p:nvSpPr>
        <p:spPr>
          <a:xfrm>
            <a:off x="563961" y="1882216"/>
            <a:ext cx="1350259" cy="210701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1E6A2164-F4F8-2865-946A-E29F87CFF850}"/>
              </a:ext>
            </a:extLst>
          </p:cNvPr>
          <p:cNvSpPr/>
          <p:nvPr/>
        </p:nvSpPr>
        <p:spPr>
          <a:xfrm>
            <a:off x="1032961" y="3542005"/>
            <a:ext cx="505968" cy="12409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</a:p>
        </p:txBody>
      </p:sp>
      <p:graphicFrame>
        <p:nvGraphicFramePr>
          <p:cNvPr id="10" name="オブジェクト 9">
            <a:extLst>
              <a:ext uri="{FF2B5EF4-FFF2-40B4-BE49-F238E27FC236}">
                <a16:creationId xmlns:a16="http://schemas.microsoft.com/office/drawing/2014/main" id="{90F4D7CD-3C34-E337-7A5A-0909ED2E1F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1306274"/>
              </p:ext>
            </p:extLst>
          </p:nvPr>
        </p:nvGraphicFramePr>
        <p:xfrm>
          <a:off x="2025923" y="1993059"/>
          <a:ext cx="2330251" cy="17406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3855613" imgH="2698634" progId="Prism8.Document">
                  <p:embed/>
                </p:oleObj>
              </mc:Choice>
              <mc:Fallback>
                <p:oleObj name="Prism 8" r:id="rId5" imgW="3855613" imgH="2698634" progId="Prism8.Document">
                  <p:embed/>
                  <p:pic>
                    <p:nvPicPr>
                      <p:cNvPr id="5" name="オブジェクト 4">
                        <a:extLst>
                          <a:ext uri="{FF2B5EF4-FFF2-40B4-BE49-F238E27FC236}">
                            <a16:creationId xmlns:a16="http://schemas.microsoft.com/office/drawing/2014/main" id="{FC17930D-70C8-2EE3-9D74-9FCB05259A3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025923" y="1993059"/>
                        <a:ext cx="2330251" cy="17406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1E7F0B0-16B9-1386-A2EC-BC8DBCACB136}"/>
              </a:ext>
            </a:extLst>
          </p:cNvPr>
          <p:cNvSpPr txBox="1"/>
          <p:nvPr/>
        </p:nvSpPr>
        <p:spPr>
          <a:xfrm>
            <a:off x="1972631" y="1722485"/>
            <a:ext cx="44541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000" b="1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7DDF153D-360A-7724-07C5-6900C31084E1}"/>
              </a:ext>
            </a:extLst>
          </p:cNvPr>
          <p:cNvSpPr/>
          <p:nvPr/>
        </p:nvSpPr>
        <p:spPr>
          <a:xfrm>
            <a:off x="3025740" y="3542005"/>
            <a:ext cx="505968" cy="12409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D6D923C2-2027-0E87-3B5E-25F917F1FF06}"/>
              </a:ext>
            </a:extLst>
          </p:cNvPr>
          <p:cNvSpPr/>
          <p:nvPr/>
        </p:nvSpPr>
        <p:spPr>
          <a:xfrm>
            <a:off x="2540519" y="1886964"/>
            <a:ext cx="1350259" cy="210701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0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maglutide</a:t>
            </a:r>
            <a:endParaRPr lang="en-US" altLang="ja-JP" sz="1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5" name="オブジェクト 14">
            <a:extLst>
              <a:ext uri="{FF2B5EF4-FFF2-40B4-BE49-F238E27FC236}">
                <a16:creationId xmlns:a16="http://schemas.microsoft.com/office/drawing/2014/main" id="{94E4C9CA-70F2-93EF-90A2-9FBCA4496D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8835805"/>
              </p:ext>
            </p:extLst>
          </p:nvPr>
        </p:nvGraphicFramePr>
        <p:xfrm>
          <a:off x="3974856" y="1993060"/>
          <a:ext cx="2330251" cy="17406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3855613" imgH="2698634" progId="Prism8.Document">
                  <p:embed/>
                </p:oleObj>
              </mc:Choice>
              <mc:Fallback>
                <p:oleObj name="Prism 8" r:id="rId7" imgW="3855613" imgH="2698634" progId="Prism8.Document">
                  <p:embed/>
                  <p:pic>
                    <p:nvPicPr>
                      <p:cNvPr id="13" name="オブジェクト 12">
                        <a:extLst>
                          <a:ext uri="{FF2B5EF4-FFF2-40B4-BE49-F238E27FC236}">
                            <a16:creationId xmlns:a16="http://schemas.microsoft.com/office/drawing/2014/main" id="{352641E3-6FFF-9E67-1A7E-633A5EAD8B6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974856" y="1993060"/>
                        <a:ext cx="2330251" cy="17406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64818C9-C9CF-CD9C-900F-850CA3445227}"/>
              </a:ext>
            </a:extLst>
          </p:cNvPr>
          <p:cNvSpPr txBox="1"/>
          <p:nvPr/>
        </p:nvSpPr>
        <p:spPr>
          <a:xfrm>
            <a:off x="3937749" y="1730081"/>
            <a:ext cx="44541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000" b="1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625AC162-3C30-DF4A-35F6-EF85E7708F90}"/>
              </a:ext>
            </a:extLst>
          </p:cNvPr>
          <p:cNvSpPr/>
          <p:nvPr/>
        </p:nvSpPr>
        <p:spPr>
          <a:xfrm>
            <a:off x="4983959" y="3529759"/>
            <a:ext cx="505968" cy="12409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425BE31B-1A81-08D3-FEB8-2374DDD0E45A}"/>
              </a:ext>
            </a:extLst>
          </p:cNvPr>
          <p:cNvSpPr/>
          <p:nvPr/>
        </p:nvSpPr>
        <p:spPr>
          <a:xfrm>
            <a:off x="4520842" y="1872466"/>
            <a:ext cx="1350259" cy="210701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0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rzepatide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D6CF5F0-420E-769A-D235-3B8D51003C50}"/>
              </a:ext>
            </a:extLst>
          </p:cNvPr>
          <p:cNvSpPr txBox="1"/>
          <p:nvPr/>
        </p:nvSpPr>
        <p:spPr>
          <a:xfrm>
            <a:off x="646560" y="3943013"/>
            <a:ext cx="5088976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A-C) Distribution of plasma lipoprotein profiles quantified by high-performance liquid chromatography (HPLC).</a:t>
            </a:r>
            <a:r>
              <a:rPr lang="ja-JP" altLang="ja-JP" sz="11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ean ± SEM (n = 4~5). </a:t>
            </a:r>
            <a:endParaRPr lang="ja-JP" altLang="ja-JP" sz="11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D3B5F6E3-0AC4-8169-DFF0-430F2E7BC565}"/>
              </a:ext>
            </a:extLst>
          </p:cNvPr>
          <p:cNvSpPr/>
          <p:nvPr/>
        </p:nvSpPr>
        <p:spPr>
          <a:xfrm rot="16200000">
            <a:off x="3727791" y="2611602"/>
            <a:ext cx="723259" cy="199183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V</a:t>
            </a: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FEB1859E-7721-DBC8-F82D-1306BF371B38}"/>
              </a:ext>
            </a:extLst>
          </p:cNvPr>
          <p:cNvSpPr/>
          <p:nvPr/>
        </p:nvSpPr>
        <p:spPr>
          <a:xfrm rot="16200000">
            <a:off x="1774945" y="2604507"/>
            <a:ext cx="723259" cy="199183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V</a:t>
            </a: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A6DDA2EA-1519-F7F7-AA09-8E1D434B975D}"/>
              </a:ext>
            </a:extLst>
          </p:cNvPr>
          <p:cNvSpPr/>
          <p:nvPr/>
        </p:nvSpPr>
        <p:spPr>
          <a:xfrm rot="16200000">
            <a:off x="-223991" y="2625773"/>
            <a:ext cx="723259" cy="199183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V</a:t>
            </a:r>
          </a:p>
        </p:txBody>
      </p:sp>
    </p:spTree>
    <p:extLst>
      <p:ext uri="{BB962C8B-B14F-4D97-AF65-F5344CB8AC3E}">
        <p14:creationId xmlns:p14="http://schemas.microsoft.com/office/powerpoint/2010/main" val="39584527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856</TotalTime>
  <Words>47</Words>
  <Application>Microsoft Office PowerPoint</Application>
  <PresentationFormat>ユーザー設定</PresentationFormat>
  <Paragraphs>15</Paragraphs>
  <Slides>1</Slides>
  <Notes>1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rism 8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pei</dc:creator>
  <cp:lastModifiedBy>和徳 段</cp:lastModifiedBy>
  <cp:revision>406</cp:revision>
  <cp:lastPrinted>2022-06-09T07:51:59Z</cp:lastPrinted>
  <dcterms:created xsi:type="dcterms:W3CDTF">2020-05-09T01:31:02Z</dcterms:created>
  <dcterms:modified xsi:type="dcterms:W3CDTF">2025-12-24T04:03:41Z</dcterms:modified>
</cp:coreProperties>
</file>